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8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>
        <p:scale>
          <a:sx n="66" d="100"/>
          <a:sy n="66" d="100"/>
        </p:scale>
        <p:origin x="1253" y="2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21" Type="http://schemas.openxmlformats.org/officeDocument/2006/relationships/theme" Target="theme/theme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9125E38-A758-4E01-826D-7F1D3DDB01FB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57D15A3-EC84-49B0-896C-AD6692F8F0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01433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57D15A3-EC84-49B0-896C-AD6692F8F0D7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149337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CD5D68-6485-3BB9-5EC5-A461E78FE71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8CDF541-003B-F5C5-19ED-F70BCEF6DB5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EEB7CB-CAAC-FC31-BA5B-2F77758A2D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CD4066-EC24-4A00-A709-88B52C425374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028294-0D70-6A71-C06A-42E2684DEA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E2E128-E257-2210-A84A-149109F845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12045-93D7-4431-BBEC-5D419F8EE2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49837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DD5D48-EE44-0BB5-7417-2AF72FBD19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8ACCB30-8AB8-E3B9-3485-91A09D361DC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3A012C-3231-7E7A-D029-93555AFFD5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CD4066-EC24-4A00-A709-88B52C425374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35E0B3B-9EAC-E7EB-B604-C3FB87CB23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CDB2BB-5067-6371-240A-0D2456C623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12045-93D7-4431-BBEC-5D419F8EE2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52821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2B60070-54CB-FF12-CE47-C26FE0DB289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3EDC138-2BC1-368A-8BA8-98F054C6068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1F529F-1994-C05A-82C4-54E565F444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CD4066-EC24-4A00-A709-88B52C425374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B09F62-D453-CC0B-BDA8-7C823758AF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EC11DC-B24C-7FD2-5E9B-DFBE25155B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12045-93D7-4431-BBEC-5D419F8EE2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36085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B607E5-B465-54F6-601C-9509D71223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A315692-E9F4-833B-EC33-A43DA897246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97D79A-D079-2DA3-4257-8752D22578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CD4066-EC24-4A00-A709-88B52C425374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41C66C-96E7-840A-6F82-AB67F4BC65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91B5B3-985C-6676-6E91-A009C93846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12045-93D7-4431-BBEC-5D419F8EE2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10446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2D9A4E-8FDB-30C7-6080-2B7598B98B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013B0E8-51E4-E34B-42FC-82FD72B6F4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63C045-E6B2-302C-0494-8E935CC413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CD4066-EC24-4A00-A709-88B52C425374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30B8B2-A0B2-F7FA-59E8-79DF638B22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FA5482-57EE-9DF0-B83A-CE4BC46A8F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12045-93D7-4431-BBEC-5D419F8EE2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47397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944B00-A8AA-F3C2-E457-3D76F41383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6987703-312B-4EA1-347F-FDE560ACEA0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69864E8-DBBB-308D-6D1E-26585394F33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AEE8083-9266-5032-40BB-8100CC06E1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CD4066-EC24-4A00-A709-88B52C425374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A9FA3EF-F811-83E1-5B1A-9E5E0EE99C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1E6D951-EF78-2C27-EC22-A1D2F6791D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12045-93D7-4431-BBEC-5D419F8EE2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83509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A2B3B6-1105-BA86-1CE7-52B77064C1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F07C525-2704-3CC8-3D91-F20EF206BC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D2B1BA4-C2F3-497A-7D5C-4BDA62545B6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9A30FFE-97BA-D0FE-9946-5D72D75F4D5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964A1E9-440E-D450-50E0-AEA3FF5B5EA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ECF4CB5-A77C-F257-FE82-9014D5663C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CD4066-EC24-4A00-A709-88B52C425374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B0D3EBE-871B-D453-2E85-73B0FD3D27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5622E6A-5EC3-A2A2-CBE6-1CF9BEC956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12045-93D7-4431-BBEC-5D419F8EE2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79613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C3FA65-D495-799A-5ED7-65816BF1B1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ABE4876-F518-3739-F27C-61BC335DE2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CD4066-EC24-4A00-A709-88B52C425374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EF4B804-5040-BF41-E438-1FD6010089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170B44D-0690-4626-29A7-3D9D2C0593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12045-93D7-4431-BBEC-5D419F8EE2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62673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5E641D0-316B-9611-AA4E-FFC72161EC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CD4066-EC24-4A00-A709-88B52C425374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6149711-7F4A-3D0D-6F60-9D764546FF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88C6AF0-1884-6D9A-0430-EDAD8D3777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12045-93D7-4431-BBEC-5D419F8EE2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39360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D86F5B-CD6A-3FA4-B069-A92C67E616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5893B13-D8E2-B485-597E-3DC5CB72A69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72AAF43-4639-1954-649C-1133E36DDD3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E3AC133-F972-EFA5-9B42-AE8E1797ED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CD4066-EC24-4A00-A709-88B52C425374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60395E4-9561-F243-C376-92D8EC703C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EAAA0F3-D412-575C-260B-97D606334C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12045-93D7-4431-BBEC-5D419F8EE2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81731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FC504E-BD3A-9724-096A-C3F1B1CA90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675A261-9826-7675-AD60-AAD3E41227C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249BC7A-8E18-9D5C-4395-4C47AEF24F6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42EF74C-17C9-2543-C317-92F9192490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CD4066-EC24-4A00-A709-88B52C425374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777A4C3-11ED-34D3-635E-4D8765B88E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1BB885A-7774-348B-7358-0D80AD3937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12045-93D7-4431-BBEC-5D419F8EE2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54788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9AF028B-57B8-3573-A919-A830F92E20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397F3C2-3B7F-4731-4B3F-3865E3DCBE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5784DC-43FE-2D82-691E-063F0D23AC7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CCD4066-EC24-4A00-A709-88B52C425374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E54FE7C-8D63-CC5C-194F-4613B6458B5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CB3D83-7F74-40E8-1050-79A3CC7EF0C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A812045-93D7-4431-BBEC-5D419F8EE2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80579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5.png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>
            <a:extLst>
              <a:ext uri="{FF2B5EF4-FFF2-40B4-BE49-F238E27FC236}">
                <a16:creationId xmlns:a16="http://schemas.microsoft.com/office/drawing/2014/main" id="{922A8300-BFB1-8D5C-DB11-2892E81E1CC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432888" y="627452"/>
            <a:ext cx="10047912" cy="3883588"/>
          </a:xfrm>
        </p:spPr>
        <p:txBody>
          <a:bodyPr>
            <a:noAutofit/>
          </a:bodyPr>
          <a:lstStyle/>
          <a:p>
            <a:r>
              <a:rPr lang="en-US" sz="3000" dirty="0">
                <a:latin typeface="Arial" panose="020B0604020202020204" pitchFamily="34" charset="0"/>
                <a:cs typeface="Arial" panose="020B0604020202020204" pitchFamily="34" charset="0"/>
              </a:rPr>
              <a:t>Gordon et al., 2025 </a:t>
            </a:r>
          </a:p>
          <a:p>
            <a:r>
              <a:rPr lang="en-US" sz="3000" dirty="0">
                <a:latin typeface="Arial" panose="020B0604020202020204" pitchFamily="34" charset="0"/>
                <a:cs typeface="Arial" panose="020B0604020202020204" pitchFamily="34" charset="0"/>
              </a:rPr>
              <a:t>Longitudinal Aging Birdsong Study</a:t>
            </a:r>
          </a:p>
          <a:p>
            <a:r>
              <a:rPr lang="en-US" sz="3000" dirty="0">
                <a:latin typeface="Arial" panose="020B0604020202020204" pitchFamily="34" charset="0"/>
                <a:cs typeface="Arial" panose="020B0604020202020204" pitchFamily="34" charset="0"/>
              </a:rPr>
              <a:t>SPSS v29 General Linearized Model Protocol </a:t>
            </a:r>
          </a:p>
          <a:p>
            <a:r>
              <a:rPr lang="en-US" sz="3000" dirty="0">
                <a:latin typeface="Arial" panose="020B0604020202020204" pitchFamily="34" charset="0"/>
                <a:cs typeface="Arial" panose="020B0604020202020204" pitchFamily="34" charset="0"/>
              </a:rPr>
              <a:t>By Julie E. Miller, University of Arizona</a:t>
            </a:r>
          </a:p>
          <a:p>
            <a:r>
              <a:rPr lang="en-US" sz="3000" dirty="0">
                <a:latin typeface="Arial" panose="020B0604020202020204" pitchFamily="34" charset="0"/>
                <a:cs typeface="Arial" panose="020B0604020202020204" pitchFamily="34" charset="0"/>
              </a:rPr>
              <a:t>September 11, 2025</a:t>
            </a:r>
          </a:p>
        </p:txBody>
      </p:sp>
    </p:spTree>
    <p:extLst>
      <p:ext uri="{BB962C8B-B14F-4D97-AF65-F5344CB8AC3E}">
        <p14:creationId xmlns:p14="http://schemas.microsoft.com/office/powerpoint/2010/main" val="226200010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FDC5274A-FEAD-AB2C-B684-83E039F90B4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30671" y="0"/>
            <a:ext cx="7846017" cy="68580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8A80998D-A200-A1D7-BAD6-79DE329BEA88}"/>
              </a:ext>
            </a:extLst>
          </p:cNvPr>
          <p:cNvSpPr txBox="1"/>
          <p:nvPr/>
        </p:nvSpPr>
        <p:spPr>
          <a:xfrm>
            <a:off x="314960" y="284480"/>
            <a:ext cx="3068320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ave Tab: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heck ‘Residual’ which will output the residuals from the model so that one can plot them on a histogram to see whether they fit a normal distribution. </a:t>
            </a:r>
          </a:p>
        </p:txBody>
      </p:sp>
    </p:spTree>
    <p:extLst>
      <p:ext uri="{BB962C8B-B14F-4D97-AF65-F5344CB8AC3E}">
        <p14:creationId xmlns:p14="http://schemas.microsoft.com/office/powerpoint/2010/main" val="50589161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222069"/>
            <a:ext cx="73148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elect Cases: If you want to look exclusively at one syllable type only-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l="25623" t="21935" r="42701" b="19532"/>
          <a:stretch/>
        </p:blipFill>
        <p:spPr>
          <a:xfrm>
            <a:off x="380358" y="862790"/>
            <a:ext cx="5397779" cy="5610581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6033247" y="1025350"/>
            <a:ext cx="6096000" cy="1200329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You can select cases (Data-&gt;Select Cases...-&gt;"If condition is satisfied"-&gt;If...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SyllableType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="Harmonic").  Make sure "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SyllableType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" is the same wording as your column and "Harmonic" is spelled indicated.  </a:t>
            </a:r>
          </a:p>
        </p:txBody>
      </p:sp>
    </p:spTree>
    <p:extLst>
      <p:ext uri="{BB962C8B-B14F-4D97-AF65-F5344CB8AC3E}">
        <p14:creationId xmlns:p14="http://schemas.microsoft.com/office/powerpoint/2010/main" val="113052451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14811" y="350178"/>
            <a:ext cx="86698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o take values and log transform them, go to ‘Transform’ and ‘Compute Variable’ …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/>
          <a:srcRect l="23206" t="16651" r="30885" b="18805"/>
          <a:stretch>
            <a:fillRect/>
          </a:stretch>
        </p:blipFill>
        <p:spPr>
          <a:xfrm>
            <a:off x="467360" y="963748"/>
            <a:ext cx="6888208" cy="54472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8459336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338534" y="1422118"/>
            <a:ext cx="108286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his is an example of syntax that lets you plot line graphs by syllable type and age or use the next slide. </a:t>
            </a:r>
          </a:p>
        </p:txBody>
      </p:sp>
      <p:sp>
        <p:nvSpPr>
          <p:cNvPr id="4" name="Rectangle 3"/>
          <p:cNvSpPr/>
          <p:nvPr/>
        </p:nvSpPr>
        <p:spPr>
          <a:xfrm>
            <a:off x="338534" y="1960734"/>
            <a:ext cx="11651848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GRAPH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/LINE(MULTIPLE)=MEAN(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CorrIntensity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) BY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Agecategory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BY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SyllType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/INTERVAL CI(95.0).</a:t>
            </a:r>
          </a:p>
        </p:txBody>
      </p:sp>
      <p:sp>
        <p:nvSpPr>
          <p:cNvPr id="5" name="Rectangle 4"/>
          <p:cNvSpPr/>
          <p:nvPr/>
        </p:nvSpPr>
        <p:spPr>
          <a:xfrm>
            <a:off x="338534" y="606503"/>
            <a:ext cx="6028125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Using Syntax to Make Graphs: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Go to ‘File’ and ‘New Syntax’ to open the coding window. </a:t>
            </a:r>
          </a:p>
        </p:txBody>
      </p:sp>
    </p:spTree>
    <p:extLst>
      <p:ext uri="{BB962C8B-B14F-4D97-AF65-F5344CB8AC3E}">
        <p14:creationId xmlns:p14="http://schemas.microsoft.com/office/powerpoint/2010/main" val="1771737403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61108" y="158541"/>
            <a:ext cx="62592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PSS: SELECT GRAPHS TAB---LEGACY DIALOG---LINE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/>
          <a:srcRect l="42463" t="26355" r="42352" b="31811"/>
          <a:stretch>
            <a:fillRect/>
          </a:stretch>
        </p:blipFill>
        <p:spPr>
          <a:xfrm>
            <a:off x="722812" y="1034756"/>
            <a:ext cx="3616618" cy="5604656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61108" y="591512"/>
            <a:ext cx="64727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TEP 1-select ‘Multiple’ and ‘Summaries for groups of cases’ 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6481925" y="591512"/>
            <a:ext cx="57247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TEP 2- Variable is your y-axis- intensity, duration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etc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cxnSp>
        <p:nvCxnSpPr>
          <p:cNvPr id="10" name="Straight Arrow Connector 9"/>
          <p:cNvCxnSpPr/>
          <p:nvPr/>
        </p:nvCxnSpPr>
        <p:spPr>
          <a:xfrm flipV="1">
            <a:off x="6310353" y="3218330"/>
            <a:ext cx="722799" cy="896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4359798" y="2711447"/>
            <a:ext cx="27492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ategory Axis is your x-axis 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5127812" y="3813526"/>
            <a:ext cx="1970732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efine Lines by:</a:t>
            </a:r>
          </a:p>
          <a:p>
            <a:r>
              <a:rPr lang="en-US" dirty="0"/>
              <a:t>Syllable Type  </a:t>
            </a:r>
          </a:p>
          <a:p>
            <a:r>
              <a:rPr lang="en-US" dirty="0"/>
              <a:t>(Harmonic, Mixed, </a:t>
            </a:r>
          </a:p>
          <a:p>
            <a:r>
              <a:rPr lang="en-US" dirty="0"/>
              <a:t>Noisy)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4"/>
          <a:srcRect l="33163" t="8398" r="33446" b="13673"/>
          <a:stretch>
            <a:fillRect/>
          </a:stretch>
        </p:blipFill>
        <p:spPr>
          <a:xfrm>
            <a:off x="7361499" y="987641"/>
            <a:ext cx="4107689" cy="539262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1551255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l="40959" t="21821" r="41215" b="28289"/>
          <a:stretch/>
        </p:blipFill>
        <p:spPr>
          <a:xfrm>
            <a:off x="2206876" y="367680"/>
            <a:ext cx="3889124" cy="612263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95226" y="278454"/>
            <a:ext cx="14799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ab: Options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6562628" y="2848723"/>
            <a:ext cx="2723823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heck-display 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error bars and determine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what you want to show</a:t>
            </a:r>
          </a:p>
        </p:txBody>
      </p:sp>
    </p:spTree>
    <p:extLst>
      <p:ext uri="{BB962C8B-B14F-4D97-AF65-F5344CB8AC3E}">
        <p14:creationId xmlns:p14="http://schemas.microsoft.com/office/powerpoint/2010/main" val="1769496441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5493732" y="167138"/>
            <a:ext cx="637238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o change the order of the x-axis categories-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or example, Young, Middle, Old, go to the ‘Categories’ tab and use the up/down arrows. </a:t>
            </a: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"/>
          <a:srcRect l="62250" t="11890" r="13227" b="20735"/>
          <a:stretch/>
        </p:blipFill>
        <p:spPr>
          <a:xfrm>
            <a:off x="8452275" y="1114634"/>
            <a:ext cx="3648892" cy="5639194"/>
          </a:xfrm>
          <a:prstGeom prst="rect">
            <a:avLst/>
          </a:prstGeom>
        </p:spPr>
      </p:pic>
      <p:sp>
        <p:nvSpPr>
          <p:cNvPr id="7" name="Rectangle 6"/>
          <p:cNvSpPr/>
          <p:nvPr/>
        </p:nvSpPr>
        <p:spPr>
          <a:xfrm>
            <a:off x="156183" y="167138"/>
            <a:ext cx="468179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Graphs: To edit the graph, double click on it.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/>
          <a:srcRect l="19626" t="12284" r="556" b="14334"/>
          <a:stretch/>
        </p:blipFill>
        <p:spPr>
          <a:xfrm>
            <a:off x="156183" y="1932770"/>
            <a:ext cx="8050645" cy="41634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095261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92730D76-0D8D-3236-F699-BF4548E61AAC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b="7207"/>
          <a:stretch/>
        </p:blipFill>
        <p:spPr>
          <a:xfrm>
            <a:off x="540774" y="1195233"/>
            <a:ext cx="9822426" cy="512690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F2D7558F-DF62-FA96-D22F-B17FD34BD82C}"/>
              </a:ext>
            </a:extLst>
          </p:cNvPr>
          <p:cNvSpPr txBox="1"/>
          <p:nvPr/>
        </p:nvSpPr>
        <p:spPr>
          <a:xfrm>
            <a:off x="277597" y="274648"/>
            <a:ext cx="73661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elect Analyze-Generalized Linear Models-Generalized Linear Models</a:t>
            </a:r>
          </a:p>
        </p:txBody>
      </p:sp>
    </p:spTree>
    <p:extLst>
      <p:ext uri="{BB962C8B-B14F-4D97-AF65-F5344CB8AC3E}">
        <p14:creationId xmlns:p14="http://schemas.microsoft.com/office/powerpoint/2010/main" val="396700051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D3C84D4A-8EAC-C4FF-B6F8-4CB8C0D97AA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19794" y="188484"/>
            <a:ext cx="7516416" cy="6481032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B1AE05F5-B9F6-9F90-0D29-6A25723D71DF}"/>
              </a:ext>
            </a:extLst>
          </p:cNvPr>
          <p:cNvSpPr txBox="1"/>
          <p:nvPr/>
        </p:nvSpPr>
        <p:spPr>
          <a:xfrm>
            <a:off x="0" y="101600"/>
            <a:ext cx="37693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ype of Model Tab: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Keep default window settings</a:t>
            </a:r>
          </a:p>
        </p:txBody>
      </p:sp>
    </p:spTree>
    <p:extLst>
      <p:ext uri="{BB962C8B-B14F-4D97-AF65-F5344CB8AC3E}">
        <p14:creationId xmlns:p14="http://schemas.microsoft.com/office/powerpoint/2010/main" val="204634918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8481638E-58FF-F3E6-E794-72EEF9668DB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09897" y="221226"/>
            <a:ext cx="7410389" cy="641554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DF03110E-5108-66F2-B933-0A913740DAF1}"/>
              </a:ext>
            </a:extLst>
          </p:cNvPr>
          <p:cNvSpPr txBox="1"/>
          <p:nvPr/>
        </p:nvSpPr>
        <p:spPr>
          <a:xfrm>
            <a:off x="101600" y="221226"/>
            <a:ext cx="3508297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Response Tab: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elect the song feature for the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ependent variable-this is 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orrected intensity (loudness) meaning the raw value was normalized based on the bird’s chamber location. </a:t>
            </a:r>
          </a:p>
        </p:txBody>
      </p:sp>
    </p:spTree>
    <p:extLst>
      <p:ext uri="{BB962C8B-B14F-4D97-AF65-F5344CB8AC3E}">
        <p14:creationId xmlns:p14="http://schemas.microsoft.com/office/powerpoint/2010/main" val="112860885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4F78D744-3A4F-4F32-6FDF-AAB2397F5D3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54847" y="403122"/>
            <a:ext cx="7115306" cy="6228735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11FE4DE5-7123-ADF0-BF16-474E2F1898C9}"/>
              </a:ext>
            </a:extLst>
          </p:cNvPr>
          <p:cNvSpPr txBox="1"/>
          <p:nvPr/>
        </p:nvSpPr>
        <p:spPr>
          <a:xfrm>
            <a:off x="211394" y="300212"/>
            <a:ext cx="2142638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Predictors Tab: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elect Factors: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ge category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yllable (Syll) Type</a:t>
            </a:r>
          </a:p>
        </p:txBody>
      </p:sp>
    </p:spTree>
    <p:extLst>
      <p:ext uri="{BB962C8B-B14F-4D97-AF65-F5344CB8AC3E}">
        <p14:creationId xmlns:p14="http://schemas.microsoft.com/office/powerpoint/2010/main" val="395715112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D411149-9D51-5F1B-A4FF-281FD981D8F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55265" y="167791"/>
            <a:ext cx="7371210" cy="6425381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D54ACF87-BB59-0E73-EF71-DEFB5BE3509B}"/>
              </a:ext>
            </a:extLst>
          </p:cNvPr>
          <p:cNvSpPr txBox="1"/>
          <p:nvPr/>
        </p:nvSpPr>
        <p:spPr>
          <a:xfrm>
            <a:off x="233680" y="167791"/>
            <a:ext cx="3799840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Model Tab: 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Move Age category and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yll Type over to the Model box.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Use the ‘Build Nested Term’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o include Age category By* Syll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ype and then add it to the Model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ox.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Make certain the box is checked for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“Include intercept in model”</a:t>
            </a:r>
          </a:p>
        </p:txBody>
      </p:sp>
    </p:spTree>
    <p:extLst>
      <p:ext uri="{BB962C8B-B14F-4D97-AF65-F5344CB8AC3E}">
        <p14:creationId xmlns:p14="http://schemas.microsoft.com/office/powerpoint/2010/main" val="290999117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F6EED0D6-08A7-8C7A-00F5-1B6F90D684B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79530" y="204182"/>
            <a:ext cx="7200892" cy="627789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FC7100EC-4C64-55BC-60C2-DC2F07460616}"/>
              </a:ext>
            </a:extLst>
          </p:cNvPr>
          <p:cNvSpPr txBox="1"/>
          <p:nvPr/>
        </p:nvSpPr>
        <p:spPr>
          <a:xfrm>
            <a:off x="182880" y="111760"/>
            <a:ext cx="37693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Estimation Tab: 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Keep default window settings</a:t>
            </a:r>
          </a:p>
        </p:txBody>
      </p:sp>
    </p:spTree>
    <p:extLst>
      <p:ext uri="{BB962C8B-B14F-4D97-AF65-F5344CB8AC3E}">
        <p14:creationId xmlns:p14="http://schemas.microsoft.com/office/powerpoint/2010/main" val="54101795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D1FC0B3F-4286-71D6-2B5F-9E441921C10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64733" y="172953"/>
            <a:ext cx="7751724" cy="668504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F030AD13-F9D4-5C7B-56AF-582667644D11}"/>
              </a:ext>
            </a:extLst>
          </p:cNvPr>
          <p:cNvSpPr txBox="1"/>
          <p:nvPr/>
        </p:nvSpPr>
        <p:spPr>
          <a:xfrm>
            <a:off x="0" y="101600"/>
            <a:ext cx="37693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tatistics Tab: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Keep default window settings</a:t>
            </a:r>
          </a:p>
        </p:txBody>
      </p:sp>
    </p:spTree>
    <p:extLst>
      <p:ext uri="{BB962C8B-B14F-4D97-AF65-F5344CB8AC3E}">
        <p14:creationId xmlns:p14="http://schemas.microsoft.com/office/powerpoint/2010/main" val="106516191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E887DE54-CE79-44CA-CBE6-F4AEB982C87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8621" y="186813"/>
            <a:ext cx="7446775" cy="6484374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A0318333-F5B1-018E-C2FD-ECCD0F76FD60}"/>
              </a:ext>
            </a:extLst>
          </p:cNvPr>
          <p:cNvSpPr txBox="1"/>
          <p:nvPr/>
        </p:nvSpPr>
        <p:spPr>
          <a:xfrm>
            <a:off x="7744152" y="186813"/>
            <a:ext cx="43665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EM Means Tab: Change to ‘Pairwise’ under Contrast tab for the post-hoc tests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8DFB8CAD-D6C2-4DFC-5351-5D522DDE4066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44143" r="2608" b="64496"/>
          <a:stretch/>
        </p:blipFill>
        <p:spPr>
          <a:xfrm>
            <a:off x="7832822" y="994144"/>
            <a:ext cx="4189227" cy="2434856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0A0FFA8C-FC65-4370-C8C8-15C753FF581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705396" y="4565868"/>
            <a:ext cx="3353268" cy="2105319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F4A85D7F-8D58-1517-2DE3-586A97C8D980}"/>
              </a:ext>
            </a:extLst>
          </p:cNvPr>
          <p:cNvSpPr txBox="1"/>
          <p:nvPr/>
        </p:nvSpPr>
        <p:spPr>
          <a:xfrm>
            <a:off x="7832822" y="4020235"/>
            <a:ext cx="418922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elect ‘Bonferroni’ under Adjustment 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or Multiple Comparisons</a:t>
            </a:r>
          </a:p>
        </p:txBody>
      </p:sp>
    </p:spTree>
    <p:extLst>
      <p:ext uri="{BB962C8B-B14F-4D97-AF65-F5344CB8AC3E}">
        <p14:creationId xmlns:p14="http://schemas.microsoft.com/office/powerpoint/2010/main" val="33634287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0</TotalTime>
  <Words>458</Words>
  <Application>Microsoft Office PowerPoint</Application>
  <PresentationFormat>Widescreen</PresentationFormat>
  <Paragraphs>59</Paragraphs>
  <Slides>16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6</vt:i4>
      </vt:variant>
    </vt:vector>
  </HeadingPairs>
  <TitlesOfParts>
    <vt:vector size="20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Julie Miller</dc:creator>
  <cp:lastModifiedBy>Julie Miller</cp:lastModifiedBy>
  <cp:revision>14</cp:revision>
  <dcterms:created xsi:type="dcterms:W3CDTF">2024-11-15T18:43:57Z</dcterms:created>
  <dcterms:modified xsi:type="dcterms:W3CDTF">2025-09-11T20:12:10Z</dcterms:modified>
</cp:coreProperties>
</file>